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7" autoAdjust="0"/>
    <p:restoredTop sz="94660"/>
  </p:normalViewPr>
  <p:slideViewPr>
    <p:cSldViewPr snapToGrid="0">
      <p:cViewPr varScale="1">
        <p:scale>
          <a:sx n="66" d="100"/>
          <a:sy n="66" d="100"/>
        </p:scale>
        <p:origin x="668" y="2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CAAEF3-9A26-42FE-94D5-F5D033A4FE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9E6803-F966-47BA-8922-2456CB5991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939B3F-25F6-436F-96A3-65B6532A91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4BA0A-39EB-491E-BA1D-9253635CD0FD}" type="datetimeFigureOut">
              <a:rPr lang="en-US" smtClean="0"/>
              <a:t>11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4CB0DB-5BA8-44FD-BFC4-3B658AAFAF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488D36-CB57-4ED3-B982-D70E8B1C6D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E75F8-158E-4A70-92EC-7CE4DB837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7380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964C8E-EA6A-4213-8CCA-EA87346AB6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6CB342-E29F-4806-8B5C-F2FF69CBF2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16742B-0EC6-4529-A7A9-ECED411A35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4BA0A-39EB-491E-BA1D-9253635CD0FD}" type="datetimeFigureOut">
              <a:rPr lang="en-US" smtClean="0"/>
              <a:t>11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B715F9-489D-4A03-ADC6-B492CACA64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637AC1-2C72-4A4C-8C0C-067C420CBF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E75F8-158E-4A70-92EC-7CE4DB837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689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3C7C876-FE78-42D6-987E-5AD49597833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E1A4AA-8EA9-4DE4-954A-8558867D52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6A86CE-51CF-4203-9687-A8D1F767AD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4BA0A-39EB-491E-BA1D-9253635CD0FD}" type="datetimeFigureOut">
              <a:rPr lang="en-US" smtClean="0"/>
              <a:t>11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28BFAD-C02E-43E8-8FC2-6C349C020B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E703AE-16DC-4F37-A891-2085EC5984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E75F8-158E-4A70-92EC-7CE4DB837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2130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B68CDC-D4A2-4BFC-B188-AECF845701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828AB8-9822-43F5-B325-3FA8A959A4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0AFE6D-DB96-459B-9B4D-2917A0AFE7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4BA0A-39EB-491E-BA1D-9253635CD0FD}" type="datetimeFigureOut">
              <a:rPr lang="en-US" smtClean="0"/>
              <a:t>11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23636E-2604-436C-8BAF-5792F617B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76FC09-46C6-4D77-8084-8BB7E76410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E75F8-158E-4A70-92EC-7CE4DB837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712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4A0B35-0D3C-430E-B623-78A0D33700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517758-50F1-49BC-971D-F731119055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F6257A-BC12-43E7-9F41-DE3762DE4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4BA0A-39EB-491E-BA1D-9253635CD0FD}" type="datetimeFigureOut">
              <a:rPr lang="en-US" smtClean="0"/>
              <a:t>11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001772-8F71-4C27-B744-CA2CEB9589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AA18AC-480C-403F-A850-61FF40AEB1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E75F8-158E-4A70-92EC-7CE4DB837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117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4533F2-658F-4D07-8CA1-734C9E4B42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5E7FC4-ADB4-49E2-8FCA-F6DA6A961D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A851A5D-A6D5-4034-AE62-B6B4AC5389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C19845-4EA8-4A49-AD99-7621CF21B7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4BA0A-39EB-491E-BA1D-9253635CD0FD}" type="datetimeFigureOut">
              <a:rPr lang="en-US" smtClean="0"/>
              <a:t>11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1C7AC1-14F8-4352-98D7-3242F01421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9459B8-9560-4C31-B1B2-CEE6D7D4F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E75F8-158E-4A70-92EC-7CE4DB837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932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D32990-22C0-4EB3-8060-70C26D4DAE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414991-4C14-480A-BF82-2A51CBB3B7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B595880-718C-45B4-9EE1-4CCD1FD5F4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7866378-3E54-4C0E-B67A-697A66B07B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30A0512-4F6D-42D2-9E28-EE7C6BD5DD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C7072E9-0C4F-4510-9709-7B840DE1D6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4BA0A-39EB-491E-BA1D-9253635CD0FD}" type="datetimeFigureOut">
              <a:rPr lang="en-US" smtClean="0"/>
              <a:t>11/24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229CCF2-67A0-4F66-90E9-35C9857E36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C828D34-08B5-4912-B30C-3505D47157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E75F8-158E-4A70-92EC-7CE4DB837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736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DA80AA-437B-4873-AFC1-71341752F7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C63799-6AF3-4C82-BF07-4AF9490513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4BA0A-39EB-491E-BA1D-9253635CD0FD}" type="datetimeFigureOut">
              <a:rPr lang="en-US" smtClean="0"/>
              <a:t>11/24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A1E3325-DA8A-46F8-81D4-AB54FDD16E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11AB6D4-AC43-4316-8EA4-6AF6D492C0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E75F8-158E-4A70-92EC-7CE4DB837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575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FC17A01-19C7-4F65-A2E0-BAF42B87DF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4BA0A-39EB-491E-BA1D-9253635CD0FD}" type="datetimeFigureOut">
              <a:rPr lang="en-US" smtClean="0"/>
              <a:t>11/24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77BE830-6689-4A43-A0BA-21E1F37DE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9EFA084-2225-4A80-8B25-817ED3934F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E75F8-158E-4A70-92EC-7CE4DB837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2923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387E42-FD6F-490C-A07B-63DF534DAF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A368C3-0D88-4E6D-A5CC-97342C05EFB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AF3621-8419-45E8-AFC5-99ECD44DBF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0678F5-5A02-4326-891F-80EB4B3C84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4BA0A-39EB-491E-BA1D-9253635CD0FD}" type="datetimeFigureOut">
              <a:rPr lang="en-US" smtClean="0"/>
              <a:t>11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3C572E-AD62-4647-86C1-8223D2CA64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AB6C3B-25B6-44A4-BA79-3D533BD101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E75F8-158E-4A70-92EC-7CE4DB837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0526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35769D-2F33-4E0C-8CEB-B38E7D5B3F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B45F350-BE8B-4A40-AFE4-B2DDB9A46B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1A28DE-5BA8-49E1-A8E4-91D9698E13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75D9EC-DB1F-4186-901A-10BB174CE6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4BA0A-39EB-491E-BA1D-9253635CD0FD}" type="datetimeFigureOut">
              <a:rPr lang="en-US" smtClean="0"/>
              <a:t>11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B7BFDF-03F2-4D09-AACE-B84824B896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7643B5-28C1-40B9-9C66-D27A9DA361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E75F8-158E-4A70-92EC-7CE4DB837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2215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56D70AC-DB46-45E6-AD69-9C54DD4936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7EB41E-7A55-43A6-AE88-015E7DF827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6DD3D6-3992-4093-808A-5578DF18B1D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D4BA0A-39EB-491E-BA1D-9253635CD0FD}" type="datetimeFigureOut">
              <a:rPr lang="en-US" smtClean="0"/>
              <a:t>11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FB55FC-EA62-4F16-8A48-80D3E63FDE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A270B4-B38B-4084-BA31-B9197B60EB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7E75F8-158E-4A70-92EC-7CE4DB837C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687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5256F0E-8CC0-4F50-88B4-3FEE074902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294" y="1024241"/>
            <a:ext cx="3940106" cy="441553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0E765226-D03E-4FF0-AF45-F40BC3AF2921}"/>
              </a:ext>
            </a:extLst>
          </p:cNvPr>
          <p:cNvSpPr txBox="1"/>
          <p:nvPr/>
        </p:nvSpPr>
        <p:spPr>
          <a:xfrm>
            <a:off x="76294" y="48134"/>
            <a:ext cx="40469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2800" dirty="0">
                <a:latin typeface="+mn-lt"/>
              </a:rPr>
              <a:t>Supplementary Figure 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ED783F8-172A-4095-943F-1893F80346D6}"/>
              </a:ext>
            </a:extLst>
          </p:cNvPr>
          <p:cNvSpPr txBox="1"/>
          <p:nvPr/>
        </p:nvSpPr>
        <p:spPr>
          <a:xfrm>
            <a:off x="78065" y="609846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6B68EC1-03BB-484B-B594-2F97F2A2CA7A}"/>
              </a:ext>
            </a:extLst>
          </p:cNvPr>
          <p:cNvSpPr txBox="1"/>
          <p:nvPr/>
        </p:nvSpPr>
        <p:spPr>
          <a:xfrm>
            <a:off x="3915387" y="609845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cs typeface="Times New Roman" panose="02020603050405020304" pitchFamily="18" charset="0"/>
              </a:rPr>
              <a:t>B</a:t>
            </a:r>
          </a:p>
        </p:txBody>
      </p:sp>
      <p:pic>
        <p:nvPicPr>
          <p:cNvPr id="2" name="Picture 9">
            <a:extLst>
              <a:ext uri="{FF2B5EF4-FFF2-40B4-BE49-F238E27FC236}">
                <a16:creationId xmlns:a16="http://schemas.microsoft.com/office/drawing/2014/main" id="{AB00ACF6-783D-7109-EB05-AB999BA090F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71151" y="1024241"/>
            <a:ext cx="3940107" cy="4463680"/>
          </a:xfrm>
          <a:prstGeom prst="rect">
            <a:avLst/>
          </a:prstGeom>
        </p:spPr>
      </p:pic>
      <p:pic>
        <p:nvPicPr>
          <p:cNvPr id="3" name="Picture 7">
            <a:extLst>
              <a:ext uri="{FF2B5EF4-FFF2-40B4-BE49-F238E27FC236}">
                <a16:creationId xmlns:a16="http://schemas.microsoft.com/office/drawing/2014/main" id="{8C9FFC1A-6E5E-64BB-C76E-2D7F4C286CC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43093" y="1024241"/>
            <a:ext cx="3940107" cy="4408741"/>
          </a:xfrm>
          <a:prstGeom prst="rect">
            <a:avLst/>
          </a:prstGeom>
        </p:spPr>
      </p:pic>
      <p:sp>
        <p:nvSpPr>
          <p:cNvPr id="4" name="TextBox 12">
            <a:extLst>
              <a:ext uri="{FF2B5EF4-FFF2-40B4-BE49-F238E27FC236}">
                <a16:creationId xmlns:a16="http://schemas.microsoft.com/office/drawing/2014/main" id="{BC4E65A3-7DE9-C713-8B4E-76E5193941CE}"/>
              </a:ext>
            </a:extLst>
          </p:cNvPr>
          <p:cNvSpPr txBox="1"/>
          <p:nvPr/>
        </p:nvSpPr>
        <p:spPr>
          <a:xfrm>
            <a:off x="7889887" y="609845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7" name="文字方塊 6">
            <a:extLst>
              <a:ext uri="{FF2B5EF4-FFF2-40B4-BE49-F238E27FC236}">
                <a16:creationId xmlns:a16="http://schemas.microsoft.com/office/drawing/2014/main" id="{ADB4B925-E8E6-C59C-CA41-E2EBA29CB21D}"/>
              </a:ext>
            </a:extLst>
          </p:cNvPr>
          <p:cNvSpPr txBox="1"/>
          <p:nvPr/>
        </p:nvSpPr>
        <p:spPr>
          <a:xfrm>
            <a:off x="263372" y="5564903"/>
            <a:ext cx="11941282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800" b="1" dirty="0">
                <a:effectLst/>
                <a:ea typeface="新細明體" panose="02020500000000000000" pitchFamily="18" charset="-120"/>
              </a:rPr>
              <a:t>Supplementary Figure 1: Subgroup analyses of receiver operating characteristic curves in the merged dataset using a </a:t>
            </a:r>
          </a:p>
          <a:p>
            <a:r>
              <a:rPr lang="en-US" altLang="zh-TW" sz="1800" b="1" dirty="0">
                <a:effectLst/>
                <a:ea typeface="新細明體" panose="02020500000000000000" pitchFamily="18" charset="-120"/>
              </a:rPr>
              <a:t>random forest model. </a:t>
            </a:r>
            <a:r>
              <a:rPr lang="en-US" altLang="zh-TW" sz="1800" dirty="0">
                <a:effectLst/>
                <a:ea typeface="新細明體" panose="02020500000000000000" pitchFamily="18" charset="-120"/>
              </a:rPr>
              <a:t>The established model, employing a random forest classifier, was subsequently evaluated for its ability </a:t>
            </a:r>
          </a:p>
          <a:p>
            <a:r>
              <a:rPr lang="en-US" altLang="zh-TW" sz="1800" dirty="0">
                <a:effectLst/>
                <a:ea typeface="新細明體" panose="02020500000000000000" pitchFamily="18" charset="-120"/>
              </a:rPr>
              <a:t>to distinguish between patients with PD (early-stage and advanced-stage) and controls in the combined language cohort,</a:t>
            </a:r>
          </a:p>
          <a:p>
            <a:r>
              <a:rPr lang="en-US" altLang="zh-TW" sz="1800" dirty="0">
                <a:effectLst/>
                <a:ea typeface="新細明體" panose="02020500000000000000" pitchFamily="18" charset="-120"/>
              </a:rPr>
              <a:t> specifically in females (A), males (B), and participants aged 40 and older (C).</a:t>
            </a:r>
            <a:endParaRPr lang="zh-TW" altLang="zh-TW" sz="1600" dirty="0">
              <a:effectLst/>
              <a:ea typeface="Malgun Gothic" panose="020B0503020000020004" pitchFamily="34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37015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D3CBD99DC7291499EB0E780E055F685" ma:contentTypeVersion="4" ma:contentTypeDescription="Create a new document." ma:contentTypeScope="" ma:versionID="1df78d34dd77e9c9561527367b57d436">
  <xsd:schema xmlns:xsd="http://www.w3.org/2001/XMLSchema" xmlns:xs="http://www.w3.org/2001/XMLSchema" xmlns:p="http://schemas.microsoft.com/office/2006/metadata/properties" xmlns:ns3="6aab1b76-f316-40af-887d-1e48eec5b14e" targetNamespace="http://schemas.microsoft.com/office/2006/metadata/properties" ma:root="true" ma:fieldsID="ad37f409502b1f6272cddbf2eb16cda1" ns3:_="">
    <xsd:import namespace="6aab1b76-f316-40af-887d-1e48eec5b14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SearchProperties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aab1b76-f316-40af-887d-1e48eec5b14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9EDCC192-67CE-48EA-8BB5-AB8AC25AB2F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aab1b76-f316-40af-887d-1e48eec5b14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79A2B181-08D4-4AD1-997A-C3B6CBBCD681}">
  <ds:schemaRefs>
    <ds:schemaRef ds:uri="6aab1b76-f316-40af-887d-1e48eec5b14e"/>
    <ds:schemaRef ds:uri="http://purl.org/dc/dcmitype/"/>
    <ds:schemaRef ds:uri="http://schemas.microsoft.com/office/2006/documentManagement/types"/>
    <ds:schemaRef ds:uri="http://www.w3.org/XML/1998/namespace"/>
    <ds:schemaRef ds:uri="http://schemas.microsoft.com/office/2006/metadata/properties"/>
    <ds:schemaRef ds:uri="http://purl.org/dc/elements/1.1/"/>
    <ds:schemaRef ds:uri="http://schemas.openxmlformats.org/package/2006/metadata/core-properties"/>
    <ds:schemaRef ds:uri="http://schemas.microsoft.com/office/infopath/2007/PartnerControls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5DA78176-A7F3-47B1-B280-995EAABF8AFD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717</TotalTime>
  <Words>82</Words>
  <Application>Microsoft Office PowerPoint</Application>
  <PresentationFormat>寬螢幕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8" baseType="lpstr">
      <vt:lpstr>Malgun Gothic</vt:lpstr>
      <vt:lpstr>新細明體</vt:lpstr>
      <vt:lpstr>Arial</vt:lpstr>
      <vt:lpstr>Calibri</vt:lpstr>
      <vt:lpstr>Calibri Light</vt:lpstr>
      <vt:lpstr>Times New Roman</vt:lpstr>
      <vt:lpstr>Office Theme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林偉莘</dc:creator>
  <cp:lastModifiedBy>Chin-Hsien Lin</cp:lastModifiedBy>
  <cp:revision>6</cp:revision>
  <dcterms:created xsi:type="dcterms:W3CDTF">2024-11-20T18:06:45Z</dcterms:created>
  <dcterms:modified xsi:type="dcterms:W3CDTF">2024-11-24T05:05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D3CBD99DC7291499EB0E780E055F685</vt:lpwstr>
  </property>
</Properties>
</file>